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FF8D90-3680-40B9-B9DD-5B0647522B6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3BA2D00-890A-4558-9AF7-DE3D1DCAA69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5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F495588-E380-43EF-A456-ABC1B02C0A5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9DA1BB-8611-4EF8-96DD-0483EDACCE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9D8510-A8E4-4FEA-A4B4-B0034D452B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81D07A-FEC9-4C1F-90A1-C9C11FBB520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3579DD-2F56-4DFD-BAE9-DCB1CC6C354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BA5189-8A0C-4E72-B72B-0C87311D05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578037-FE72-4B72-A5F7-EA83927C53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7F17D4-04A0-49FD-9B5D-75A70100EC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69BEA3-BBCF-4B17-B477-C97D64775E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891773-C22C-4DFA-A2CA-3797FA65AD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89FEAE-5059-4488-91BF-837C31A78A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AB80E6-E785-4A5A-9DA7-88A9424930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B557BA-0EE1-4373-9B5D-CFB8F456BB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4953319-29D6-468E-AE00-C354D74FF6A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96"/>
          <p:cNvGrpSpPr/>
          <p:nvPr/>
        </p:nvGrpSpPr>
        <p:grpSpPr>
          <a:xfrm>
            <a:off x="905040" y="108000"/>
            <a:ext cx="7906680" cy="438480"/>
            <a:chOff x="905040" y="108000"/>
            <a:chExt cx="7906680" cy="438480"/>
          </a:xfrm>
        </p:grpSpPr>
        <p:grpSp>
          <p:nvGrpSpPr>
            <p:cNvPr id="49" name="Group 90"/>
            <p:cNvGrpSpPr/>
            <p:nvPr/>
          </p:nvGrpSpPr>
          <p:grpSpPr>
            <a:xfrm>
              <a:off x="1009800" y="266040"/>
              <a:ext cx="7675560" cy="280440"/>
              <a:chOff x="1009800" y="266040"/>
              <a:chExt cx="7675560" cy="280440"/>
            </a:xfrm>
          </p:grpSpPr>
          <p:grpSp>
            <p:nvGrpSpPr>
              <p:cNvPr id="50" name="Group 85"/>
              <p:cNvGrpSpPr/>
              <p:nvPr/>
            </p:nvGrpSpPr>
            <p:grpSpPr>
              <a:xfrm>
                <a:off x="1009800" y="317880"/>
                <a:ext cx="7675560" cy="186480"/>
                <a:chOff x="1009800" y="317880"/>
                <a:chExt cx="7675560" cy="186480"/>
              </a:xfrm>
            </p:grpSpPr>
            <p:sp>
              <p:nvSpPr>
                <p:cNvPr id="51" name="Rectangle 81"/>
                <p:cNvSpPr/>
                <p:nvPr/>
              </p:nvSpPr>
              <p:spPr>
                <a:xfrm>
                  <a:off x="1009800" y="317880"/>
                  <a:ext cx="1695600" cy="186480"/>
                </a:xfrm>
                <a:prstGeom prst="rect">
                  <a:avLst/>
                </a:prstGeom>
                <a:solidFill>
                  <a:srgbClr val="808080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Rectangle 82"/>
                <p:cNvSpPr/>
                <p:nvPr/>
              </p:nvSpPr>
              <p:spPr>
                <a:xfrm>
                  <a:off x="2694240" y="317880"/>
                  <a:ext cx="2544120" cy="186480"/>
                </a:xfrm>
                <a:prstGeom prst="rect">
                  <a:avLst/>
                </a:prstGeom>
                <a:solidFill>
                  <a:srgbClr val="808080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Rectangle 83"/>
                <p:cNvSpPr/>
                <p:nvPr/>
              </p:nvSpPr>
              <p:spPr>
                <a:xfrm>
                  <a:off x="5231880" y="317880"/>
                  <a:ext cx="2630520" cy="186480"/>
                </a:xfrm>
                <a:prstGeom prst="rect">
                  <a:avLst/>
                </a:prstGeom>
                <a:solidFill>
                  <a:srgbClr val="808080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Rectangle 84"/>
                <p:cNvSpPr/>
                <p:nvPr/>
              </p:nvSpPr>
              <p:spPr>
                <a:xfrm>
                  <a:off x="7836120" y="317880"/>
                  <a:ext cx="849240" cy="186480"/>
                </a:xfrm>
                <a:prstGeom prst="rect">
                  <a:avLst/>
                </a:prstGeom>
                <a:solidFill>
                  <a:srgbClr val="808080"/>
                </a:solidFill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5" name="Text Box 86"/>
              <p:cNvSpPr/>
              <p:nvPr/>
            </p:nvSpPr>
            <p:spPr>
              <a:xfrm>
                <a:off x="1647360" y="270000"/>
                <a:ext cx="429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C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Text Box 87"/>
              <p:cNvSpPr/>
              <p:nvPr/>
            </p:nvSpPr>
            <p:spPr>
              <a:xfrm>
                <a:off x="3638160" y="266040"/>
                <a:ext cx="539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NB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Text Box 88"/>
              <p:cNvSpPr/>
              <p:nvPr/>
            </p:nvSpPr>
            <p:spPr>
              <a:xfrm>
                <a:off x="6248160" y="266040"/>
                <a:ext cx="502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LRR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Text Box 89"/>
              <p:cNvSpPr/>
              <p:nvPr/>
            </p:nvSpPr>
            <p:spPr>
              <a:xfrm>
                <a:off x="7991280" y="270000"/>
                <a:ext cx="612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</a:rPr>
                  <a:t>CtN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9" name="Text Box 91"/>
            <p:cNvSpPr/>
            <p:nvPr/>
          </p:nvSpPr>
          <p:spPr>
            <a:xfrm>
              <a:off x="905040" y="110520"/>
              <a:ext cx="304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92"/>
            <p:cNvSpPr/>
            <p:nvPr/>
          </p:nvSpPr>
          <p:spPr>
            <a:xfrm>
              <a:off x="2600280" y="108000"/>
              <a:ext cx="580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26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93"/>
            <p:cNvSpPr/>
            <p:nvPr/>
          </p:nvSpPr>
          <p:spPr>
            <a:xfrm>
              <a:off x="5133960" y="108000"/>
              <a:ext cx="580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63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94"/>
            <p:cNvSpPr/>
            <p:nvPr/>
          </p:nvSpPr>
          <p:spPr>
            <a:xfrm>
              <a:off x="7734240" y="110520"/>
              <a:ext cx="580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10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95"/>
            <p:cNvSpPr/>
            <p:nvPr/>
          </p:nvSpPr>
          <p:spPr>
            <a:xfrm>
              <a:off x="8381880" y="108000"/>
              <a:ext cx="4298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114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4" name="Group 102"/>
          <p:cNvGrpSpPr/>
          <p:nvPr/>
        </p:nvGrpSpPr>
        <p:grpSpPr>
          <a:xfrm>
            <a:off x="228600" y="609480"/>
            <a:ext cx="8675280" cy="6120000"/>
            <a:chOff x="228600" y="609480"/>
            <a:chExt cx="8675280" cy="6120000"/>
          </a:xfrm>
        </p:grpSpPr>
        <p:pic>
          <p:nvPicPr>
            <p:cNvPr id="65" name="Picture 100" descr="序列比对图"/>
            <p:cNvPicPr/>
            <p:nvPr/>
          </p:nvPicPr>
          <p:blipFill>
            <a:blip r:embed="rId1"/>
            <a:srcRect l="5170" t="0" r="0" b="0"/>
            <a:stretch/>
          </p:blipFill>
          <p:spPr>
            <a:xfrm>
              <a:off x="228600" y="609480"/>
              <a:ext cx="8675280" cy="612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Rectangle 101"/>
            <p:cNvSpPr/>
            <p:nvPr/>
          </p:nvSpPr>
          <p:spPr>
            <a:xfrm>
              <a:off x="3854880" y="1370880"/>
              <a:ext cx="4212000" cy="5601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7" name="矩形 1"/>
          <p:cNvSpPr/>
          <p:nvPr/>
        </p:nvSpPr>
        <p:spPr>
          <a:xfrm>
            <a:off x="160200" y="228600"/>
            <a:ext cx="397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Group 100"/>
          <p:cNvGrpSpPr/>
          <p:nvPr/>
        </p:nvGrpSpPr>
        <p:grpSpPr>
          <a:xfrm>
            <a:off x="1171440" y="168120"/>
            <a:ext cx="7515360" cy="450000"/>
            <a:chOff x="1171440" y="168120"/>
            <a:chExt cx="7515360" cy="450000"/>
          </a:xfrm>
        </p:grpSpPr>
        <p:grpSp>
          <p:nvGrpSpPr>
            <p:cNvPr id="69" name="Group 97"/>
            <p:cNvGrpSpPr/>
            <p:nvPr/>
          </p:nvGrpSpPr>
          <p:grpSpPr>
            <a:xfrm>
              <a:off x="1266840" y="389520"/>
              <a:ext cx="7295400" cy="172440"/>
              <a:chOff x="1266840" y="389520"/>
              <a:chExt cx="7295400" cy="172440"/>
            </a:xfrm>
          </p:grpSpPr>
          <p:sp>
            <p:nvSpPr>
              <p:cNvPr id="70" name="Rectangle 84"/>
              <p:cNvSpPr/>
              <p:nvPr/>
            </p:nvSpPr>
            <p:spPr>
              <a:xfrm>
                <a:off x="1266840" y="389520"/>
                <a:ext cx="1441080" cy="172440"/>
              </a:xfrm>
              <a:prstGeom prst="rect">
                <a:avLst/>
              </a:prstGeom>
              <a:solidFill>
                <a:srgbClr val="80808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Rectangle 85"/>
              <p:cNvSpPr/>
              <p:nvPr/>
            </p:nvSpPr>
            <p:spPr>
              <a:xfrm>
                <a:off x="2707920" y="389520"/>
                <a:ext cx="2642040" cy="172440"/>
              </a:xfrm>
              <a:prstGeom prst="rect">
                <a:avLst/>
              </a:prstGeom>
              <a:solidFill>
                <a:srgbClr val="80808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Rectangle 86"/>
              <p:cNvSpPr/>
              <p:nvPr/>
            </p:nvSpPr>
            <p:spPr>
              <a:xfrm>
                <a:off x="5357520" y="389520"/>
                <a:ext cx="3204720" cy="172440"/>
              </a:xfrm>
              <a:prstGeom prst="rect">
                <a:avLst/>
              </a:prstGeom>
              <a:solidFill>
                <a:srgbClr val="808080"/>
              </a:solidFill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3" name="Text Box 88"/>
            <p:cNvSpPr/>
            <p:nvPr/>
          </p:nvSpPr>
          <p:spPr>
            <a:xfrm>
              <a:off x="1780920" y="341640"/>
              <a:ext cx="838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C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89"/>
            <p:cNvSpPr/>
            <p:nvPr/>
          </p:nvSpPr>
          <p:spPr>
            <a:xfrm>
              <a:off x="3695400" y="341640"/>
              <a:ext cx="838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NB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 Box 90"/>
            <p:cNvSpPr/>
            <p:nvPr/>
          </p:nvSpPr>
          <p:spPr>
            <a:xfrm>
              <a:off x="6724440" y="341640"/>
              <a:ext cx="838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LR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92"/>
            <p:cNvSpPr/>
            <p:nvPr/>
          </p:nvSpPr>
          <p:spPr>
            <a:xfrm>
              <a:off x="1171440" y="171360"/>
              <a:ext cx="304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93"/>
            <p:cNvSpPr/>
            <p:nvPr/>
          </p:nvSpPr>
          <p:spPr>
            <a:xfrm>
              <a:off x="2609640" y="168120"/>
              <a:ext cx="581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18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94"/>
            <p:cNvSpPr/>
            <p:nvPr/>
          </p:nvSpPr>
          <p:spPr>
            <a:xfrm>
              <a:off x="5257800" y="168120"/>
              <a:ext cx="581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6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95"/>
            <p:cNvSpPr/>
            <p:nvPr/>
          </p:nvSpPr>
          <p:spPr>
            <a:xfrm>
              <a:off x="8219880" y="171360"/>
              <a:ext cx="466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102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" name="Text Box 99"/>
          <p:cNvSpPr/>
          <p:nvPr/>
        </p:nvSpPr>
        <p:spPr>
          <a:xfrm>
            <a:off x="1371600" y="5989680"/>
            <a:ext cx="6624720" cy="77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Times New Roman"/>
              </a:rPr>
              <a:t>Figure S3. Alignment of predicted polypeptide sequences encoded by the </a:t>
            </a:r>
            <a:r>
              <a:rPr b="1" i="1" lang="en-GB" sz="1100" spc="-1" strike="noStrike">
                <a:solidFill>
                  <a:srgbClr val="000000"/>
                </a:solidFill>
                <a:latin typeface="Times New Roman"/>
              </a:rPr>
              <a:t>Pik </a:t>
            </a:r>
            <a:r>
              <a:rPr b="1" lang="en-GB" sz="1100" spc="-1" strike="noStrike">
                <a:solidFill>
                  <a:srgbClr val="000000"/>
                </a:solidFill>
                <a:latin typeface="Times New Roman"/>
              </a:rPr>
              <a:t>paired genes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Times New Roman"/>
              </a:rPr>
              <a:t>(A)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</a:rPr>
              <a:t>The Pik-1 alleles. The sequences in the black box are predicted as RATX1 motif (see Cesari et al. [6])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Times New Roman"/>
              </a:rPr>
              <a:t>(B)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</a:rPr>
              <a:t> The Pik-2 alleles. The gene structures are also indicated at the top (see Zhai et al. [35])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Picture 104" descr="k2"/>
          <p:cNvPicPr/>
          <p:nvPr/>
        </p:nvPicPr>
        <p:blipFill>
          <a:blip r:embed="rId1"/>
          <a:srcRect l="3446" t="0" r="0" b="0"/>
          <a:stretch/>
        </p:blipFill>
        <p:spPr>
          <a:xfrm>
            <a:off x="380880" y="668160"/>
            <a:ext cx="8382240" cy="5329440"/>
          </a:xfrm>
          <a:prstGeom prst="rect">
            <a:avLst/>
          </a:prstGeom>
          <a:ln w="0">
            <a:noFill/>
          </a:ln>
        </p:spPr>
      </p:pic>
      <p:sp>
        <p:nvSpPr>
          <p:cNvPr id="82" name="矩形 1"/>
          <p:cNvSpPr/>
          <p:nvPr/>
        </p:nvSpPr>
        <p:spPr>
          <a:xfrm>
            <a:off x="271440" y="355680"/>
            <a:ext cx="39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Times New Roman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Qinghua Pan</cp:lastModifiedBy>
  <cp:lastPrinted>2013-11-07T13:01:02Z</cp:lastPrinted>
  <dcterms:modified xsi:type="dcterms:W3CDTF">2014-05-03T02:50:48Z</dcterms:modified>
  <cp:revision>48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